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slideLayouts/slideLayout3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  <p:sldMasterId id="2147483662" r:id="rId2"/>
    <p:sldMasterId id="2147483660" r:id="rId3"/>
  </p:sldMasterIdLst>
  <p:notesMasterIdLst>
    <p:notesMasterId r:id="rId22"/>
  </p:notesMasterIdLst>
  <p:sldIdLst>
    <p:sldId id="256" r:id="rId4"/>
    <p:sldId id="287" r:id="rId5"/>
    <p:sldId id="288" r:id="rId6"/>
    <p:sldId id="293" r:id="rId7"/>
    <p:sldId id="290" r:id="rId8"/>
    <p:sldId id="292" r:id="rId9"/>
    <p:sldId id="291" r:id="rId10"/>
    <p:sldId id="294" r:id="rId11"/>
    <p:sldId id="295" r:id="rId12"/>
    <p:sldId id="296" r:id="rId13"/>
    <p:sldId id="289" r:id="rId14"/>
    <p:sldId id="297" r:id="rId15"/>
    <p:sldId id="278" r:id="rId16"/>
    <p:sldId id="286" r:id="rId17"/>
    <p:sldId id="301" r:id="rId18"/>
    <p:sldId id="300" r:id="rId19"/>
    <p:sldId id="298" r:id="rId20"/>
    <p:sldId id="299" r:id="rId21"/>
  </p:sldIdLst>
  <p:sldSz cx="8640763" cy="6483350"/>
  <p:notesSz cx="6858000" cy="9144000"/>
  <p:defaultTextStyle>
    <a:defPPr>
      <a:defRPr lang="en-US"/>
    </a:defPPr>
    <a:lvl1pPr marL="0" algn="l" defTabSz="43210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32100" algn="l" defTabSz="43210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64199" algn="l" defTabSz="43210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296299" algn="l" defTabSz="43210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728399" algn="l" defTabSz="43210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160499" algn="l" defTabSz="43210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592598" algn="l" defTabSz="43210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3024698" algn="l" defTabSz="43210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456798" algn="l" defTabSz="432100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42">
          <p15:clr>
            <a:srgbClr val="A4A3A4"/>
          </p15:clr>
        </p15:guide>
        <p15:guide id="2" pos="272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or Drukker" initials="LD" lastIdx="1" clrIdx="0">
    <p:extLst>
      <p:ext uri="{19B8F6BF-5375-455C-9EA6-DF929625EA0E}">
        <p15:presenceInfo xmlns:p15="http://schemas.microsoft.com/office/powerpoint/2012/main" userId="Lior Drukk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047" autoAdjust="0"/>
  </p:normalViewPr>
  <p:slideViewPr>
    <p:cSldViewPr snapToGrid="0" snapToObjects="1">
      <p:cViewPr varScale="1">
        <p:scale>
          <a:sx n="104" d="100"/>
          <a:sy n="104" d="100"/>
        </p:scale>
        <p:origin x="1986" y="114"/>
      </p:cViewPr>
      <p:guideLst>
        <p:guide orient="horz" pos="2042"/>
        <p:guide pos="272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slide" Target="slides/slide10.xml"/><Relationship Id="rId18" Type="http://schemas.openxmlformats.org/officeDocument/2006/relationships/slide" Target="slides/slide15.xml"/><Relationship Id="rId26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21" Type="http://schemas.openxmlformats.org/officeDocument/2006/relationships/slide" Target="slides/slide18.xml"/><Relationship Id="rId7" Type="http://schemas.openxmlformats.org/officeDocument/2006/relationships/slide" Target="slides/slide4.xml"/><Relationship Id="rId12" Type="http://schemas.openxmlformats.org/officeDocument/2006/relationships/slide" Target="slides/slide9.xml"/><Relationship Id="rId17" Type="http://schemas.openxmlformats.org/officeDocument/2006/relationships/slide" Target="slides/slide14.xml"/><Relationship Id="rId25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3.xml"/><Relationship Id="rId20" Type="http://schemas.openxmlformats.org/officeDocument/2006/relationships/slide" Target="slides/slide17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24" Type="http://schemas.openxmlformats.org/officeDocument/2006/relationships/presProps" Target="presProps.xml"/><Relationship Id="rId5" Type="http://schemas.openxmlformats.org/officeDocument/2006/relationships/slide" Target="slides/slide2.xml"/><Relationship Id="rId15" Type="http://schemas.openxmlformats.org/officeDocument/2006/relationships/slide" Target="slides/slide12.xml"/><Relationship Id="rId23" Type="http://schemas.openxmlformats.org/officeDocument/2006/relationships/commentAuthors" Target="commentAuthors.xml"/><Relationship Id="rId10" Type="http://schemas.openxmlformats.org/officeDocument/2006/relationships/slide" Target="slides/slide7.xml"/><Relationship Id="rId19" Type="http://schemas.openxmlformats.org/officeDocument/2006/relationships/slide" Target="slides/slide16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slide" Target="slides/slide11.xml"/><Relationship Id="rId22" Type="http://schemas.openxmlformats.org/officeDocument/2006/relationships/notesMaster" Target="notesMasters/notesMaster1.xml"/><Relationship Id="rId27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D2050661-21B9-B849-A49E-4EF013B898D4}" type="doc">
      <dgm:prSet loTypeId="urn:microsoft.com/office/officeart/2005/8/layout/hProcess9" loCatId="" qsTypeId="urn:microsoft.com/office/officeart/2005/8/quickstyle/simple4" qsCatId="simple" csTypeId="urn:microsoft.com/office/officeart/2005/8/colors/accent1_2" csCatId="accent1" phldr="1"/>
      <dgm:spPr/>
    </dgm:pt>
    <dgm:pt modelId="{6FA6061F-3782-5147-A7D3-2B83C7F91EB6}">
      <dgm:prSet phldrT="[Text]" custT="1"/>
      <dgm:spPr/>
      <dgm:t>
        <a:bodyPr/>
        <a:lstStyle/>
        <a:p>
          <a:r>
            <a:rPr lang="en-US" sz="2000" dirty="0" smtClean="0"/>
            <a:t>Pregnancy</a:t>
          </a:r>
          <a:endParaRPr lang="en-US" sz="2000" dirty="0"/>
        </a:p>
      </dgm:t>
    </dgm:pt>
    <dgm:pt modelId="{D9571BDA-49B8-7843-A6A7-D0E6FD11A028}" type="parTrans" cxnId="{144BFC3F-0AC0-AD4A-93C4-8CB4AB5C23DE}">
      <dgm:prSet/>
      <dgm:spPr/>
      <dgm:t>
        <a:bodyPr/>
        <a:lstStyle/>
        <a:p>
          <a:endParaRPr lang="en-US"/>
        </a:p>
      </dgm:t>
    </dgm:pt>
    <dgm:pt modelId="{E98D9B05-BA01-D940-AF3B-A727F598C47F}" type="sibTrans" cxnId="{144BFC3F-0AC0-AD4A-93C4-8CB4AB5C23DE}">
      <dgm:prSet/>
      <dgm:spPr/>
      <dgm:t>
        <a:bodyPr/>
        <a:lstStyle/>
        <a:p>
          <a:endParaRPr lang="en-US"/>
        </a:p>
      </dgm:t>
    </dgm:pt>
    <dgm:pt modelId="{EC933A48-3366-6F40-B851-ED528F4A4D87}">
      <dgm:prSet phldrT="[Text]" custT="1"/>
      <dgm:spPr/>
      <dgm:t>
        <a:bodyPr/>
        <a:lstStyle/>
        <a:p>
          <a:r>
            <a:rPr lang="en-US" sz="2000" dirty="0" smtClean="0"/>
            <a:t>Birth</a:t>
          </a:r>
          <a:endParaRPr lang="en-US" sz="2000" dirty="0"/>
        </a:p>
      </dgm:t>
    </dgm:pt>
    <dgm:pt modelId="{3507052C-D8C6-DE40-BA4B-87D062E8A532}" type="parTrans" cxnId="{57E1F994-AF9D-E946-A2BB-AA9A17234BA1}">
      <dgm:prSet/>
      <dgm:spPr/>
      <dgm:t>
        <a:bodyPr/>
        <a:lstStyle/>
        <a:p>
          <a:endParaRPr lang="en-US"/>
        </a:p>
      </dgm:t>
    </dgm:pt>
    <dgm:pt modelId="{831DF78C-28CC-DD4E-AC94-C395D872BF27}" type="sibTrans" cxnId="{57E1F994-AF9D-E946-A2BB-AA9A17234BA1}">
      <dgm:prSet/>
      <dgm:spPr/>
      <dgm:t>
        <a:bodyPr/>
        <a:lstStyle/>
        <a:p>
          <a:endParaRPr lang="en-US"/>
        </a:p>
      </dgm:t>
    </dgm:pt>
    <dgm:pt modelId="{D959C6AA-EAB0-1140-B303-096A3C418141}">
      <dgm:prSet phldrT="[Text]" custT="1"/>
      <dgm:spPr/>
      <dgm:t>
        <a:bodyPr/>
        <a:lstStyle/>
        <a:p>
          <a:r>
            <a:rPr lang="en-US" sz="2000" dirty="0" smtClean="0"/>
            <a:t>1 year</a:t>
          </a:r>
          <a:endParaRPr lang="en-US" sz="2000" dirty="0"/>
        </a:p>
      </dgm:t>
    </dgm:pt>
    <dgm:pt modelId="{E06E96B7-26F2-DC48-B7CD-059C9648BE53}" type="parTrans" cxnId="{0C35C451-2105-1D48-AA41-AD4F1618B5E5}">
      <dgm:prSet/>
      <dgm:spPr/>
      <dgm:t>
        <a:bodyPr/>
        <a:lstStyle/>
        <a:p>
          <a:endParaRPr lang="en-US"/>
        </a:p>
      </dgm:t>
    </dgm:pt>
    <dgm:pt modelId="{34A81757-F5BC-7A46-8727-3EC6DAFFCA59}" type="sibTrans" cxnId="{0C35C451-2105-1D48-AA41-AD4F1618B5E5}">
      <dgm:prSet/>
      <dgm:spPr/>
      <dgm:t>
        <a:bodyPr/>
        <a:lstStyle/>
        <a:p>
          <a:endParaRPr lang="en-US"/>
        </a:p>
      </dgm:t>
    </dgm:pt>
    <dgm:pt modelId="{BE9398A2-EDFA-B648-837D-CA598FFCE30F}">
      <dgm:prSet custT="1"/>
      <dgm:spPr/>
      <dgm:t>
        <a:bodyPr/>
        <a:lstStyle/>
        <a:p>
          <a:r>
            <a:rPr lang="en-US" sz="2000" dirty="0" smtClean="0"/>
            <a:t>2 years</a:t>
          </a:r>
          <a:endParaRPr lang="en-US" sz="2000" dirty="0"/>
        </a:p>
      </dgm:t>
    </dgm:pt>
    <dgm:pt modelId="{5FF48F86-36FB-1949-852A-F40C460AD559}" type="parTrans" cxnId="{CFE71C5C-9D3F-FD49-A9A9-ACDB332541A4}">
      <dgm:prSet/>
      <dgm:spPr/>
      <dgm:t>
        <a:bodyPr/>
        <a:lstStyle/>
        <a:p>
          <a:endParaRPr lang="en-US"/>
        </a:p>
      </dgm:t>
    </dgm:pt>
    <dgm:pt modelId="{69B41B2F-C89E-4641-BAFE-11330D4CFA38}" type="sibTrans" cxnId="{CFE71C5C-9D3F-FD49-A9A9-ACDB332541A4}">
      <dgm:prSet/>
      <dgm:spPr/>
      <dgm:t>
        <a:bodyPr/>
        <a:lstStyle/>
        <a:p>
          <a:endParaRPr lang="en-US"/>
        </a:p>
      </dgm:t>
    </dgm:pt>
    <dgm:pt modelId="{09A4D70B-F37D-9B47-8F49-3E295579EC2E}" type="pres">
      <dgm:prSet presAssocID="{D2050661-21B9-B849-A49E-4EF013B898D4}" presName="CompostProcess" presStyleCnt="0">
        <dgm:presLayoutVars>
          <dgm:dir/>
          <dgm:resizeHandles val="exact"/>
        </dgm:presLayoutVars>
      </dgm:prSet>
      <dgm:spPr/>
    </dgm:pt>
    <dgm:pt modelId="{8053D781-1C08-004D-A117-D9E4DB0D660B}" type="pres">
      <dgm:prSet presAssocID="{D2050661-21B9-B849-A49E-4EF013B898D4}" presName="arrow" presStyleLbl="bgShp" presStyleIdx="0" presStyleCnt="1" custLinFactNeighborX="3266" custLinFactNeighborY="-39886"/>
      <dgm:spPr/>
    </dgm:pt>
    <dgm:pt modelId="{25F1B8C6-E829-9342-A0E3-236F5D998A42}" type="pres">
      <dgm:prSet presAssocID="{D2050661-21B9-B849-A49E-4EF013B898D4}" presName="linearProcess" presStyleCnt="0"/>
      <dgm:spPr/>
    </dgm:pt>
    <dgm:pt modelId="{F8EA8D90-4464-4341-9331-75DF7BF3B3C1}" type="pres">
      <dgm:prSet presAssocID="{6FA6061F-3782-5147-A7D3-2B83C7F91EB6}" presName="textNode" presStyleLbl="node1" presStyleIdx="0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0C386569-2ECC-D64C-9C4B-78C72ED22CE6}" type="pres">
      <dgm:prSet presAssocID="{E98D9B05-BA01-D940-AF3B-A727F598C47F}" presName="sibTrans" presStyleCnt="0"/>
      <dgm:spPr/>
    </dgm:pt>
    <dgm:pt modelId="{C29C377B-31B6-B149-9743-40D3AB53746D}" type="pres">
      <dgm:prSet presAssocID="{EC933A48-3366-6F40-B851-ED528F4A4D87}" presName="textNode" presStyleLbl="node1" presStyleIdx="1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D92E10F-F903-C64D-868C-F753BE564ABF}" type="pres">
      <dgm:prSet presAssocID="{831DF78C-28CC-DD4E-AC94-C395D872BF27}" presName="sibTrans" presStyleCnt="0"/>
      <dgm:spPr/>
    </dgm:pt>
    <dgm:pt modelId="{DD4942E2-8CB0-B54E-9924-D2D5F05CB316}" type="pres">
      <dgm:prSet presAssocID="{D959C6AA-EAB0-1140-B303-096A3C418141}" presName="textNode" presStyleLbl="node1" presStyleIdx="2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AB58FEFC-A962-0149-836E-B44EDB276682}" type="pres">
      <dgm:prSet presAssocID="{34A81757-F5BC-7A46-8727-3EC6DAFFCA59}" presName="sibTrans" presStyleCnt="0"/>
      <dgm:spPr/>
    </dgm:pt>
    <dgm:pt modelId="{9607DEE5-96B8-0543-8B24-DC0C57F07789}" type="pres">
      <dgm:prSet presAssocID="{BE9398A2-EDFA-B648-837D-CA598FFCE30F}" presName="textNode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57E1F994-AF9D-E946-A2BB-AA9A17234BA1}" srcId="{D2050661-21B9-B849-A49E-4EF013B898D4}" destId="{EC933A48-3366-6F40-B851-ED528F4A4D87}" srcOrd="1" destOrd="0" parTransId="{3507052C-D8C6-DE40-BA4B-87D062E8A532}" sibTransId="{831DF78C-28CC-DD4E-AC94-C395D872BF27}"/>
    <dgm:cxn modelId="{144BFC3F-0AC0-AD4A-93C4-8CB4AB5C23DE}" srcId="{D2050661-21B9-B849-A49E-4EF013B898D4}" destId="{6FA6061F-3782-5147-A7D3-2B83C7F91EB6}" srcOrd="0" destOrd="0" parTransId="{D9571BDA-49B8-7843-A6A7-D0E6FD11A028}" sibTransId="{E98D9B05-BA01-D940-AF3B-A727F598C47F}"/>
    <dgm:cxn modelId="{CFE71C5C-9D3F-FD49-A9A9-ACDB332541A4}" srcId="{D2050661-21B9-B849-A49E-4EF013B898D4}" destId="{BE9398A2-EDFA-B648-837D-CA598FFCE30F}" srcOrd="3" destOrd="0" parTransId="{5FF48F86-36FB-1949-852A-F40C460AD559}" sibTransId="{69B41B2F-C89E-4641-BAFE-11330D4CFA38}"/>
    <dgm:cxn modelId="{81778A6E-134D-4F25-A0A6-24F290A088A3}" type="presOf" srcId="{D959C6AA-EAB0-1140-B303-096A3C418141}" destId="{DD4942E2-8CB0-B54E-9924-D2D5F05CB316}" srcOrd="0" destOrd="0" presId="urn:microsoft.com/office/officeart/2005/8/layout/hProcess9"/>
    <dgm:cxn modelId="{5D6BAF27-8AB4-4C74-861C-4E7E1CE139C6}" type="presOf" srcId="{D2050661-21B9-B849-A49E-4EF013B898D4}" destId="{09A4D70B-F37D-9B47-8F49-3E295579EC2E}" srcOrd="0" destOrd="0" presId="urn:microsoft.com/office/officeart/2005/8/layout/hProcess9"/>
    <dgm:cxn modelId="{78FF91CE-A366-4EF6-8D9D-C90A5AAE64A5}" type="presOf" srcId="{6FA6061F-3782-5147-A7D3-2B83C7F91EB6}" destId="{F8EA8D90-4464-4341-9331-75DF7BF3B3C1}" srcOrd="0" destOrd="0" presId="urn:microsoft.com/office/officeart/2005/8/layout/hProcess9"/>
    <dgm:cxn modelId="{776BB49F-88FA-47C9-BDA5-5B0C56F155C1}" type="presOf" srcId="{BE9398A2-EDFA-B648-837D-CA598FFCE30F}" destId="{9607DEE5-96B8-0543-8B24-DC0C57F07789}" srcOrd="0" destOrd="0" presId="urn:microsoft.com/office/officeart/2005/8/layout/hProcess9"/>
    <dgm:cxn modelId="{86A7026F-1F86-4AE5-965C-0B29B449CAC5}" type="presOf" srcId="{EC933A48-3366-6F40-B851-ED528F4A4D87}" destId="{C29C377B-31B6-B149-9743-40D3AB53746D}" srcOrd="0" destOrd="0" presId="urn:microsoft.com/office/officeart/2005/8/layout/hProcess9"/>
    <dgm:cxn modelId="{0C35C451-2105-1D48-AA41-AD4F1618B5E5}" srcId="{D2050661-21B9-B849-A49E-4EF013B898D4}" destId="{D959C6AA-EAB0-1140-B303-096A3C418141}" srcOrd="2" destOrd="0" parTransId="{E06E96B7-26F2-DC48-B7CD-059C9648BE53}" sibTransId="{34A81757-F5BC-7A46-8727-3EC6DAFFCA59}"/>
    <dgm:cxn modelId="{F8373BCD-CCD3-4C5C-9AD8-CC4F9F3315E3}" type="presParOf" srcId="{09A4D70B-F37D-9B47-8F49-3E295579EC2E}" destId="{8053D781-1C08-004D-A117-D9E4DB0D660B}" srcOrd="0" destOrd="0" presId="urn:microsoft.com/office/officeart/2005/8/layout/hProcess9"/>
    <dgm:cxn modelId="{86D6F57B-2559-4286-9D5F-1EFDF6D73C43}" type="presParOf" srcId="{09A4D70B-F37D-9B47-8F49-3E295579EC2E}" destId="{25F1B8C6-E829-9342-A0E3-236F5D998A42}" srcOrd="1" destOrd="0" presId="urn:microsoft.com/office/officeart/2005/8/layout/hProcess9"/>
    <dgm:cxn modelId="{80BEAF65-B88C-45E0-8E4E-CA8B4A5BAD3D}" type="presParOf" srcId="{25F1B8C6-E829-9342-A0E3-236F5D998A42}" destId="{F8EA8D90-4464-4341-9331-75DF7BF3B3C1}" srcOrd="0" destOrd="0" presId="urn:microsoft.com/office/officeart/2005/8/layout/hProcess9"/>
    <dgm:cxn modelId="{C051A389-D99F-4EAE-810F-6D118484642F}" type="presParOf" srcId="{25F1B8C6-E829-9342-A0E3-236F5D998A42}" destId="{0C386569-2ECC-D64C-9C4B-78C72ED22CE6}" srcOrd="1" destOrd="0" presId="urn:microsoft.com/office/officeart/2005/8/layout/hProcess9"/>
    <dgm:cxn modelId="{F11335D6-1A59-4904-B498-34420C2D7DA6}" type="presParOf" srcId="{25F1B8C6-E829-9342-A0E3-236F5D998A42}" destId="{C29C377B-31B6-B149-9743-40D3AB53746D}" srcOrd="2" destOrd="0" presId="urn:microsoft.com/office/officeart/2005/8/layout/hProcess9"/>
    <dgm:cxn modelId="{013C8839-9C42-4378-875F-B0DC2EB5C6DB}" type="presParOf" srcId="{25F1B8C6-E829-9342-A0E3-236F5D998A42}" destId="{9D92E10F-F903-C64D-868C-F753BE564ABF}" srcOrd="3" destOrd="0" presId="urn:microsoft.com/office/officeart/2005/8/layout/hProcess9"/>
    <dgm:cxn modelId="{D36BCDC2-82F5-4D56-B51F-540F5CFC3EF8}" type="presParOf" srcId="{25F1B8C6-E829-9342-A0E3-236F5D998A42}" destId="{DD4942E2-8CB0-B54E-9924-D2D5F05CB316}" srcOrd="4" destOrd="0" presId="urn:microsoft.com/office/officeart/2005/8/layout/hProcess9"/>
    <dgm:cxn modelId="{E21B2C09-963A-40AF-A219-8A7203B29CD7}" type="presParOf" srcId="{25F1B8C6-E829-9342-A0E3-236F5D998A42}" destId="{AB58FEFC-A962-0149-836E-B44EDB276682}" srcOrd="5" destOrd="0" presId="urn:microsoft.com/office/officeart/2005/8/layout/hProcess9"/>
    <dgm:cxn modelId="{93BAA03F-B5D8-47AA-BAE7-C959082B11EB}" type="presParOf" srcId="{25F1B8C6-E829-9342-A0E3-236F5D998A42}" destId="{9607DEE5-96B8-0543-8B24-DC0C57F07789}" srcOrd="6" destOrd="0" presId="urn:microsoft.com/office/officeart/2005/8/layout/hProcess9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053D781-1C08-004D-A117-D9E4DB0D660B}">
      <dsp:nvSpPr>
        <dsp:cNvPr id="0" name=""/>
        <dsp:cNvSpPr/>
      </dsp:nvSpPr>
      <dsp:spPr>
        <a:xfrm>
          <a:off x="868148" y="0"/>
          <a:ext cx="7180998" cy="1862834"/>
        </a:xfrm>
        <a:prstGeom prst="rightArrow">
          <a:avLst/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F8EA8D90-4464-4341-9331-75DF7BF3B3C1}">
      <dsp:nvSpPr>
        <dsp:cNvPr id="0" name=""/>
        <dsp:cNvSpPr/>
      </dsp:nvSpPr>
      <dsp:spPr>
        <a:xfrm>
          <a:off x="2887" y="558850"/>
          <a:ext cx="1876101" cy="745133"/>
        </a:xfrm>
        <a:prstGeom prst="roundRect">
          <a:avLst/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000" kern="1200" dirty="0" smtClean="0"/>
            <a:t>Pregnancy</a:t>
          </a:r>
          <a:endParaRPr lang="en-US" sz="2000" kern="1200" dirty="0"/>
        </a:p>
      </dsp:txBody>
      <dsp:txXfrm>
        <a:off x="39261" y="595224"/>
        <a:ext cx="1803353" cy="672385"/>
      </dsp:txXfrm>
    </dsp:sp>
    <dsp:sp modelId="{C29C377B-31B6-B149-9743-40D3AB53746D}">
      <dsp:nvSpPr>
        <dsp:cNvPr id="0" name=""/>
        <dsp:cNvSpPr/>
      </dsp:nvSpPr>
      <dsp:spPr>
        <a:xfrm>
          <a:off x="2191672" y="558850"/>
          <a:ext cx="1876101" cy="745133"/>
        </a:xfrm>
        <a:prstGeom prst="roundRect">
          <a:avLst/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000" kern="1200" dirty="0" smtClean="0"/>
            <a:t>Birth</a:t>
          </a:r>
          <a:endParaRPr lang="en-US" sz="2000" kern="1200" dirty="0"/>
        </a:p>
      </dsp:txBody>
      <dsp:txXfrm>
        <a:off x="2228046" y="595224"/>
        <a:ext cx="1803353" cy="672385"/>
      </dsp:txXfrm>
    </dsp:sp>
    <dsp:sp modelId="{DD4942E2-8CB0-B54E-9924-D2D5F05CB316}">
      <dsp:nvSpPr>
        <dsp:cNvPr id="0" name=""/>
        <dsp:cNvSpPr/>
      </dsp:nvSpPr>
      <dsp:spPr>
        <a:xfrm>
          <a:off x="4380458" y="558850"/>
          <a:ext cx="1876101" cy="745133"/>
        </a:xfrm>
        <a:prstGeom prst="roundRect">
          <a:avLst/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000" kern="1200" dirty="0" smtClean="0"/>
            <a:t>1 year</a:t>
          </a:r>
          <a:endParaRPr lang="en-US" sz="2000" kern="1200" dirty="0"/>
        </a:p>
      </dsp:txBody>
      <dsp:txXfrm>
        <a:off x="4416832" y="595224"/>
        <a:ext cx="1803353" cy="672385"/>
      </dsp:txXfrm>
    </dsp:sp>
    <dsp:sp modelId="{9607DEE5-96B8-0543-8B24-DC0C57F07789}">
      <dsp:nvSpPr>
        <dsp:cNvPr id="0" name=""/>
        <dsp:cNvSpPr/>
      </dsp:nvSpPr>
      <dsp:spPr>
        <a:xfrm>
          <a:off x="6569243" y="558850"/>
          <a:ext cx="1876101" cy="745133"/>
        </a:xfrm>
        <a:prstGeom prst="roundRect">
          <a:avLst/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000" kern="1200" dirty="0" smtClean="0"/>
            <a:t>2 years</a:t>
          </a:r>
          <a:endParaRPr lang="en-US" sz="2000" kern="1200" dirty="0"/>
        </a:p>
      </dsp:txBody>
      <dsp:txXfrm>
        <a:off x="6605617" y="595224"/>
        <a:ext cx="1803353" cy="672385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Process9">
  <dgm:title val=""/>
  <dgm:desc val=""/>
  <dgm:catLst>
    <dgm:cat type="process" pri="5000"/>
    <dgm:cat type="convert" pri="13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CompostProcess">
    <dgm:varLst>
      <dgm:dir/>
      <dgm:resizeHandles val="exact"/>
    </dgm:varLst>
    <dgm:alg type="composite">
      <dgm:param type="horzAlign" val="ctr"/>
      <dgm:param type="vertAlign" val="mid"/>
    </dgm:alg>
    <dgm:shape xmlns:r="http://schemas.openxmlformats.org/officeDocument/2006/relationships" r:blip="">
      <dgm:adjLst/>
    </dgm:shape>
    <dgm:presOf/>
    <dgm:constrLst>
      <dgm:constr type="w" for="ch" forName="arrow" refType="w" fact="0.85"/>
      <dgm:constr type="h" for="ch" forName="arrow" refType="h"/>
      <dgm:constr type="ctrX" for="ch" forName="arrow" refType="w" fact="0.5"/>
      <dgm:constr type="ctrY" for="ch" forName="arrow" refType="h" fact="0.5"/>
      <dgm:constr type="w" for="ch" forName="linearProcess" refType="w"/>
      <dgm:constr type="h" for="ch" forName="linearProcess" refType="h" fact="0.4"/>
      <dgm:constr type="ctrX" for="ch" forName="linearProcess" refType="w" fact="0.5"/>
      <dgm:constr type="ctrY" for="ch" forName="linearProcess" refType="h" fact="0.5"/>
    </dgm:constrLst>
    <dgm:ruleLst/>
    <dgm:layoutNode name="arrow" styleLbl="bgShp">
      <dgm:alg type="sp"/>
      <dgm:choose name="Name0">
        <dgm:if name="Name1" func="var" arg="dir" op="equ" val="norm">
          <dgm:shape xmlns:r="http://schemas.openxmlformats.org/officeDocument/2006/relationships" type="rightArrow" r:blip="">
            <dgm:adjLst/>
          </dgm:shape>
        </dgm:if>
        <dgm:else name="Name2">
          <dgm:shape xmlns:r="http://schemas.openxmlformats.org/officeDocument/2006/relationships" type="leftArrow" r:blip="">
            <dgm:adjLst/>
          </dgm:shape>
        </dgm:else>
      </dgm:choose>
      <dgm:presOf/>
      <dgm:constrLst/>
      <dgm:ruleLst/>
    </dgm:layoutNode>
    <dgm:layoutNode name="linearProcess">
      <dgm:choose name="Name3">
        <dgm:if name="Name4" func="var" arg="dir" op="equ" val="norm">
          <dgm:alg type="lin"/>
        </dgm:if>
        <dgm:else name="Name5">
          <dgm:alg type="lin">
            <dgm:param type="linDir" val="fromR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userA" for="ch" ptType="node" refType="w"/>
        <dgm:constr type="h" for="ch" ptType="node" refType="h"/>
        <dgm:constr type="w" for="ch" ptType="node" op="equ"/>
        <dgm:constr type="w" for="ch" forName="sibTrans" refType="w" fact="0.05"/>
        <dgm:constr type="primFontSz" for="ch" ptType="node" op="equ" val="65"/>
      </dgm:constrLst>
      <dgm:ruleLst/>
      <dgm:forEach name="Name6" axis="ch" ptType="node">
        <dgm:layoutNode name="textNode" styleLbl="node1">
          <dgm:varLst>
            <dgm:bulletEnabled val="1"/>
          </dgm:varLst>
          <dgm:alg type="tx"/>
          <dgm:shape xmlns:r="http://schemas.openxmlformats.org/officeDocument/2006/relationships" type="roundRect" r:blip="">
            <dgm:adjLst/>
          </dgm:shape>
          <dgm:presOf axis="desOrSelf" ptType="node"/>
          <dgm:constrLst>
            <dgm:constr type="userA"/>
            <dgm:constr type="w" refType="userA" fact="0.3"/>
            <dgm:constr type="tMarg" refType="primFontSz" fact="0.3"/>
            <dgm:constr type="bMarg" refType="primFontSz" fact="0.3"/>
            <dgm:constr type="lMarg" refType="primFontSz" fact="0.3"/>
            <dgm:constr type="rMarg" refType="primFontSz" fact="0.3"/>
          </dgm:constrLst>
          <dgm:ruleLst>
            <dgm:rule type="w" val="NaN" fact="1" max="NaN"/>
            <dgm:rule type="primFontSz" val="5" fact="NaN" max="NaN"/>
          </dgm:ruleLst>
        </dgm:layoutNode>
        <dgm:forEach name="Name7" axis="followSib" ptType="sibTrans" cnt="1">
          <dgm:layoutNode name="sibTrans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</dgm:forEach>
      </dgm:forEach>
    </dgm:layoutNod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image" Target="../media/image7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1D60BD-C49E-4BFA-916B-C8FEF137FD85}" type="datetimeFigureOut">
              <a:rPr lang="en-GB" smtClean="0"/>
              <a:t>09/1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4588" y="685800"/>
            <a:ext cx="45688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5917CA-6BF6-4ABC-B9CD-B223A86EA6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38989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131635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3782708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4379109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1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8275755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1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2100013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1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899604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1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1243336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1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6857642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1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4274578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1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5683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07567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652584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72957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865935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944022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055310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88331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5917CA-6BF6-4ABC-B9CD-B223A86EA6B9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1606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23371094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>
        <p14:prism dir="u" isInverted="1"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4473521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>
        <p14:prism dir="u" isInverted="1"/>
      </p:transition>
    </mc:Choice>
    <mc:Fallback xmlns="">
      <p:transition spd="med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7933366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>
        <p14:prism dir="u" isInverted="1"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eg"/><Relationship Id="rId4" Type="http://schemas.openxmlformats.org/officeDocument/2006/relationships/image" Target="../media/image2.jp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5.png"/><Relationship Id="rId4" Type="http://schemas.openxmlformats.org/officeDocument/2006/relationships/image" Target="../media/image3.jpe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RWattsDSC_0055_retouchedforPP2.jpg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5070"/>
            <a:ext cx="8640763" cy="5668279"/>
          </a:xfrm>
          <a:prstGeom prst="rect">
            <a:avLst/>
          </a:prstGeom>
        </p:spPr>
      </p:pic>
      <p:pic>
        <p:nvPicPr>
          <p:cNvPr id="8" name="Picture 7" descr="ox_small_cmyk_pos_rect.jpg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5107" y="178883"/>
            <a:ext cx="1521068" cy="468528"/>
          </a:xfrm>
          <a:prstGeom prst="rect">
            <a:avLst/>
          </a:prstGeom>
        </p:spPr>
      </p:pic>
      <p:pic>
        <p:nvPicPr>
          <p:cNvPr id="6" name="Picture 7" descr="INTERGROWTH LOGO.jpg">
            <a:extLst>
              <a:ext uri="{FF2B5EF4-FFF2-40B4-BE49-F238E27FC236}">
                <a16:creationId xmlns:a16="http://schemas.microsoft.com/office/drawing/2014/main" id="{FF11DA8A-4BEE-4F83-967A-2716A0FE1F00}"/>
              </a:ext>
            </a:extLst>
          </p:cNvPr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459" y="51935"/>
            <a:ext cx="1009912" cy="6107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04531F1-3224-4A09-9661-C2CAE566E78E}"/>
              </a:ext>
            </a:extLst>
          </p:cNvPr>
          <p:cNvSpPr txBox="1"/>
          <p:nvPr userDrawn="1"/>
        </p:nvSpPr>
        <p:spPr>
          <a:xfrm>
            <a:off x="78814" y="633968"/>
            <a:ext cx="1111202" cy="2308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GB" sz="900" dirty="0"/>
              <a:t>INTERGROWTH-21</a:t>
            </a:r>
            <a:r>
              <a:rPr lang="en-GB" sz="900" baseline="30000" dirty="0"/>
              <a:t>st</a:t>
            </a:r>
            <a:endParaRPr lang="he-IL" sz="900" baseline="30000" dirty="0"/>
          </a:p>
        </p:txBody>
      </p:sp>
    </p:spTree>
    <p:extLst>
      <p:ext uri="{BB962C8B-B14F-4D97-AF65-F5344CB8AC3E}">
        <p14:creationId xmlns:p14="http://schemas.microsoft.com/office/powerpoint/2010/main" val="2116942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mc:AlternateContent xmlns:mc="http://schemas.openxmlformats.org/markup-compatibility/2006" xmlns:p14="http://schemas.microsoft.com/office/powerpoint/2010/main">
    <mc:Choice Requires="p14">
      <p:transition spd="med">
        <p14:prism dir="u" isInverted="1"/>
      </p:transition>
    </mc:Choice>
    <mc:Fallback xmlns="">
      <p:transition spd="med">
        <p:fade/>
      </p:transition>
    </mc:Fallback>
  </mc:AlternateContent>
  <p:txStyles>
    <p:titleStyle>
      <a:lvl1pPr algn="ctr" defTabSz="432100" rtl="0" eaLnBrk="1" latinLnBrk="0" hangingPunct="1">
        <a:spcBef>
          <a:spcPct val="0"/>
        </a:spcBef>
        <a:buNone/>
        <a:defRPr sz="4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075" indent="-324075" algn="l" defTabSz="432100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02162" indent="-270062" algn="l" defTabSz="432100" rtl="0" eaLnBrk="1" latinLnBrk="0" hangingPunct="1">
        <a:spcBef>
          <a:spcPct val="20000"/>
        </a:spcBef>
        <a:buFont typeface="Arial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80249" indent="-216050" algn="l" defTabSz="432100" rtl="0" eaLnBrk="1" latinLnBrk="0" hangingPunct="1">
        <a:spcBef>
          <a:spcPct val="20000"/>
        </a:spcBef>
        <a:buFont typeface="Arial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512349" indent="-216050" algn="l" defTabSz="432100" rtl="0" eaLnBrk="1" latinLnBrk="0" hangingPunct="1">
        <a:spcBef>
          <a:spcPct val="20000"/>
        </a:spcBef>
        <a:buFont typeface="Arial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44449" indent="-216050" algn="l" defTabSz="432100" rtl="0" eaLnBrk="1" latinLnBrk="0" hangingPunct="1">
        <a:spcBef>
          <a:spcPct val="20000"/>
        </a:spcBef>
        <a:buFont typeface="Arial"/>
        <a:buChar char="»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765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086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2407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6728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32100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641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962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283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604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92598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024698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456798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RWatts_punts_retouchedforPP.jpg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5070"/>
            <a:ext cx="8638032" cy="5668279"/>
          </a:xfrm>
          <a:prstGeom prst="rect">
            <a:avLst/>
          </a:prstGeom>
        </p:spPr>
      </p:pic>
      <p:sp>
        <p:nvSpPr>
          <p:cNvPr id="13" name="TextBox 12"/>
          <p:cNvSpPr txBox="1"/>
          <p:nvPr userDrawn="1"/>
        </p:nvSpPr>
        <p:spPr>
          <a:xfrm>
            <a:off x="482511" y="339634"/>
            <a:ext cx="50402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FoundrySterling-Book"/>
              </a:rPr>
              <a:t>Department or office title: change on Slide Master</a:t>
            </a:r>
          </a:p>
        </p:txBody>
      </p:sp>
      <p:pic>
        <p:nvPicPr>
          <p:cNvPr id="16" name="Picture 15" descr="ox_small_cmyk_pos_rect.jpg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5107" y="178883"/>
            <a:ext cx="1521068" cy="4685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8086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</p:sldLayoutIdLst>
  <mc:AlternateContent xmlns:mc="http://schemas.openxmlformats.org/markup-compatibility/2006" xmlns:p14="http://schemas.microsoft.com/office/powerpoint/2010/main">
    <mc:Choice Requires="p14">
      <p:transition spd="med">
        <p14:prism dir="u" isInverted="1"/>
      </p:transition>
    </mc:Choice>
    <mc:Fallback xmlns="">
      <p:transition spd="med">
        <p:fade/>
      </p:transition>
    </mc:Fallback>
  </mc:AlternateContent>
  <p:txStyles>
    <p:titleStyle>
      <a:lvl1pPr algn="ctr" defTabSz="432100" rtl="0" eaLnBrk="1" latinLnBrk="0" hangingPunct="1">
        <a:spcBef>
          <a:spcPct val="0"/>
        </a:spcBef>
        <a:buNone/>
        <a:defRPr sz="4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075" indent="-324075" algn="l" defTabSz="432100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02162" indent="-270062" algn="l" defTabSz="432100" rtl="0" eaLnBrk="1" latinLnBrk="0" hangingPunct="1">
        <a:spcBef>
          <a:spcPct val="20000"/>
        </a:spcBef>
        <a:buFont typeface="Arial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80249" indent="-216050" algn="l" defTabSz="432100" rtl="0" eaLnBrk="1" latinLnBrk="0" hangingPunct="1">
        <a:spcBef>
          <a:spcPct val="20000"/>
        </a:spcBef>
        <a:buFont typeface="Arial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512349" indent="-216050" algn="l" defTabSz="432100" rtl="0" eaLnBrk="1" latinLnBrk="0" hangingPunct="1">
        <a:spcBef>
          <a:spcPct val="20000"/>
        </a:spcBef>
        <a:buFont typeface="Arial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44449" indent="-216050" algn="l" defTabSz="432100" rtl="0" eaLnBrk="1" latinLnBrk="0" hangingPunct="1">
        <a:spcBef>
          <a:spcPct val="20000"/>
        </a:spcBef>
        <a:buFont typeface="Arial"/>
        <a:buChar char="»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765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086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2407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6728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32100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641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962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283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604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92598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024698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456798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ox_small_cmyk_pos_rect.jpg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5107" y="178883"/>
            <a:ext cx="1521068" cy="468528"/>
          </a:xfrm>
          <a:prstGeom prst="rect">
            <a:avLst/>
          </a:prstGeom>
        </p:spPr>
      </p:pic>
      <p:sp>
        <p:nvSpPr>
          <p:cNvPr id="12" name="Rectangle 11"/>
          <p:cNvSpPr>
            <a:spLocks noChangeArrowheads="1"/>
          </p:cNvSpPr>
          <p:nvPr userDrawn="1"/>
        </p:nvSpPr>
        <p:spPr bwMode="auto">
          <a:xfrm>
            <a:off x="-1" y="815072"/>
            <a:ext cx="8640763" cy="501832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>
            <a:outerShdw dist="23000" dir="5400000" rotWithShape="0">
              <a:srgbClr val="000000">
                <a:alpha val="34998"/>
              </a:srgbClr>
            </a:outerShdw>
          </a:effec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solidFill>
                <a:schemeClr val="lt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6" name="Picture 7" descr="INTERGROWTH LOGO.jpg">
            <a:extLst>
              <a:ext uri="{FF2B5EF4-FFF2-40B4-BE49-F238E27FC236}">
                <a16:creationId xmlns:a16="http://schemas.microsoft.com/office/drawing/2014/main" id="{0209A501-3E1F-427F-A9E1-86A23AACE525}"/>
              </a:ext>
            </a:extLst>
          </p:cNvPr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459" y="51935"/>
            <a:ext cx="1009912" cy="6107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1C80ACF-9600-4677-BD9B-D5DC646E7F36}"/>
              </a:ext>
            </a:extLst>
          </p:cNvPr>
          <p:cNvSpPr txBox="1"/>
          <p:nvPr userDrawn="1"/>
        </p:nvSpPr>
        <p:spPr>
          <a:xfrm>
            <a:off x="78814" y="633968"/>
            <a:ext cx="1111202" cy="2308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GB" sz="900" dirty="0"/>
              <a:t>INTERGROWTH-21</a:t>
            </a:r>
            <a:r>
              <a:rPr lang="en-GB" sz="900" baseline="30000" dirty="0"/>
              <a:t>st</a:t>
            </a:r>
            <a:endParaRPr lang="he-IL" sz="900" baseline="30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3C52870-02A4-48B7-A6E4-981872362744}"/>
              </a:ext>
            </a:extLst>
          </p:cNvPr>
          <p:cNvSpPr txBox="1"/>
          <p:nvPr userDrawn="1"/>
        </p:nvSpPr>
        <p:spPr>
          <a:xfrm>
            <a:off x="1" y="5923537"/>
            <a:ext cx="8640762" cy="50783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0" marR="0" lvl="0" indent="0" algn="l" defTabSz="4321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rukker L, </a:t>
            </a:r>
            <a:r>
              <a:rPr lang="en-US" sz="9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aines-Urias</a:t>
            </a: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, </a:t>
            </a:r>
            <a:r>
              <a:rPr lang="en-US" sz="9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illar</a:t>
            </a: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J, Barros FC, </a:t>
            </a:r>
            <a:r>
              <a:rPr lang="en-US" sz="9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rvalho</a:t>
            </a: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, </a:t>
            </a:r>
            <a:r>
              <a:rPr lang="en-US" sz="9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nim</a:t>
            </a: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, </a:t>
            </a:r>
            <a:r>
              <a:rPr lang="en-US" sz="9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cGready</a:t>
            </a: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, </a:t>
            </a:r>
            <a:r>
              <a:rPr lang="en-US" sz="9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sten</a:t>
            </a: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, Berkley JA, Norris SA, </a:t>
            </a:r>
            <a:r>
              <a:rPr lang="en-US" sz="9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auy</a:t>
            </a: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, Kennedy SH, </a:t>
            </a:r>
            <a:r>
              <a:rPr lang="en-US" sz="9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pageorghiou</a:t>
            </a: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T</a:t>
            </a:r>
          </a:p>
          <a:p>
            <a:pPr marL="0" marR="0" lvl="0" indent="0" algn="l" defTabSz="4321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ternational gestational age-specific centiles for umbilical artery Doppler indices: a longitudinal prospective cohort study of the INTERGROWTH-21st Project </a:t>
            </a:r>
          </a:p>
          <a:p>
            <a:pPr marL="0" marR="0" lvl="0" indent="0" algn="l" defTabSz="4321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m J </a:t>
            </a:r>
            <a:r>
              <a:rPr lang="en-US" sz="9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bstet</a:t>
            </a:r>
            <a:r>
              <a:rPr lang="en-US" sz="9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ynecol. 2020</a:t>
            </a:r>
            <a:endParaRPr lang="en-US" sz="900" b="1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/>
          <a:stretch>
            <a:fillRect/>
          </a:stretch>
        </p:blipFill>
        <p:spPr>
          <a:xfrm>
            <a:off x="7683145" y="5890915"/>
            <a:ext cx="902286" cy="5730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834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4" r:id="rId1"/>
  </p:sldLayoutIdLst>
  <mc:AlternateContent xmlns:mc="http://schemas.openxmlformats.org/markup-compatibility/2006" xmlns:p14="http://schemas.microsoft.com/office/powerpoint/2010/main">
    <mc:Choice Requires="p14">
      <p:transition spd="med">
        <p14:prism dir="u" isInverted="1"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  <p:txStyles>
    <p:titleStyle>
      <a:lvl1pPr algn="ctr" defTabSz="432100" rtl="0" eaLnBrk="1" latinLnBrk="0" hangingPunct="1">
        <a:spcBef>
          <a:spcPct val="0"/>
        </a:spcBef>
        <a:buNone/>
        <a:defRPr sz="4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075" indent="-324075" algn="l" defTabSz="432100" rtl="0" eaLnBrk="1" latinLnBrk="0" hangingPunct="1">
        <a:spcBef>
          <a:spcPct val="20000"/>
        </a:spcBef>
        <a:buFont typeface="Arial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02162" indent="-270062" algn="l" defTabSz="432100" rtl="0" eaLnBrk="1" latinLnBrk="0" hangingPunct="1">
        <a:spcBef>
          <a:spcPct val="20000"/>
        </a:spcBef>
        <a:buFont typeface="Arial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80249" indent="-216050" algn="l" defTabSz="432100" rtl="0" eaLnBrk="1" latinLnBrk="0" hangingPunct="1">
        <a:spcBef>
          <a:spcPct val="20000"/>
        </a:spcBef>
        <a:buFont typeface="Arial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512349" indent="-216050" algn="l" defTabSz="432100" rtl="0" eaLnBrk="1" latinLnBrk="0" hangingPunct="1">
        <a:spcBef>
          <a:spcPct val="20000"/>
        </a:spcBef>
        <a:buFont typeface="Arial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44449" indent="-216050" algn="l" defTabSz="432100" rtl="0" eaLnBrk="1" latinLnBrk="0" hangingPunct="1">
        <a:spcBef>
          <a:spcPct val="20000"/>
        </a:spcBef>
        <a:buFont typeface="Arial"/>
        <a:buChar char="»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765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086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2407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672848" indent="-216050" algn="l" defTabSz="43210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32100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641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962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283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60499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92598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024698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456798" algn="l" defTabSz="432100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3.xml"/><Relationship Id="rId4" Type="http://schemas.microsoft.com/office/2007/relationships/hdphoto" Target="../media/hdphoto3.wdp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3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3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3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3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3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3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7.png"/><Relationship Id="rId2" Type="http://schemas.openxmlformats.org/officeDocument/2006/relationships/slideLayout" Target="../slideLayouts/slideLayout3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9.png"/><Relationship Id="rId5" Type="http://schemas.microsoft.com/office/2007/relationships/hdphoto" Target="../media/hdphoto1.wdp"/><Relationship Id="rId10" Type="http://schemas.openxmlformats.org/officeDocument/2006/relationships/oleObject" Target="../embeddings/oleObject3.bin"/><Relationship Id="rId4" Type="http://schemas.openxmlformats.org/officeDocument/2006/relationships/image" Target="../media/image10.png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Relationship Id="rId4" Type="http://schemas.microsoft.com/office/2007/relationships/hdphoto" Target="../media/hdphoto2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25424" y="2133336"/>
            <a:ext cx="5994401" cy="40934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u="sng" dirty="0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FoundrySterling-Book"/>
            </a:endParaRPr>
          </a:p>
          <a:p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Lior Drukker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1,2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</a:t>
            </a:r>
            <a:r>
              <a:rPr lang="en-US" sz="16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Eleonora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Staines-Urias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1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José Villar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1,2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Fernando </a:t>
            </a:r>
            <a:r>
              <a:rPr lang="en-US" sz="16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C. 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Barros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3,4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Maria Carvalho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5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</a:t>
            </a:r>
            <a:r>
              <a:rPr lang="en-US" sz="16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Shama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Munim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6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Rose McGready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7,8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Francois Nosten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7,8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James </a:t>
            </a:r>
            <a:r>
              <a:rPr lang="en-US" sz="16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A. 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Berkley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8,9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Shane A Norris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10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Ricardo Uauy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11,12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Stephen </a:t>
            </a:r>
            <a:r>
              <a:rPr lang="en-US" sz="16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H. 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Kennedy</a:t>
            </a:r>
            <a:r>
              <a:rPr lang="en-US" sz="16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1,2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</a:t>
            </a:r>
            <a:r>
              <a:rPr lang="en-US" sz="16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Aris</a:t>
            </a:r>
            <a:r>
              <a:rPr lang="en-US" sz="16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</a:t>
            </a:r>
            <a:r>
              <a:rPr lang="en-US" sz="16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T. Papageorghiou</a:t>
            </a:r>
            <a:r>
              <a:rPr lang="en-US" sz="1600" baseline="300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1,2</a:t>
            </a:r>
          </a:p>
          <a:p>
            <a:endParaRPr lang="en-GB" sz="1600" dirty="0" smtClean="0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FoundrySterling-Book"/>
            </a:endParaRPr>
          </a:p>
          <a:p>
            <a:r>
              <a:rPr lang="en-US" sz="12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Affiliations</a:t>
            </a:r>
            <a:endParaRPr lang="en-US" sz="1200" dirty="0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FoundrySterling-Book"/>
            </a:endParaRPr>
          </a:p>
          <a:p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1 Nuffield Department of Women’s &amp; Reproductive Health, University of Oxford, Oxford, United Kingdom</a:t>
            </a:r>
          </a:p>
          <a:p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2 Oxford Maternal &amp; Perinatal Health Institute, Green Templeton College, University of Oxford, Oxford, </a:t>
            </a:r>
            <a:endParaRPr lang="en-US" sz="800" dirty="0" smtClean="0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FoundrySterling-Book"/>
            </a:endParaRPr>
          </a:p>
          <a:p>
            <a:r>
              <a:rPr lang="en-US" sz="8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United 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Kingdom</a:t>
            </a:r>
          </a:p>
          <a:p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3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Programa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de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Pós-Graduação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em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Saúde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e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Comportamento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Universidade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Católica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de Pelotas, Pelotas, Brazil</a:t>
            </a:r>
          </a:p>
          <a:p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4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Programa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de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Pós-Graduação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em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Epidemiologia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Universidade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Federal de Pelotas, Pelotas, Brazil</a:t>
            </a:r>
          </a:p>
          <a:p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5 Faculty of Health Sciences, Aga Khan University, Nairobi, Kenya</a:t>
            </a:r>
          </a:p>
          <a:p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6 Department of Obstetrics and Gynecology, Aga Khan University Hospital, Karachi, Pakistan</a:t>
            </a:r>
          </a:p>
          <a:p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7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Shoklo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Malaria Research Unit,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Mahidol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-Oxford Tropical Medicine Research Unit, </a:t>
            </a:r>
            <a:endParaRPr lang="en-US" sz="800" dirty="0" smtClean="0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FoundrySterling-Book"/>
            </a:endParaRPr>
          </a:p>
          <a:p>
            <a:r>
              <a:rPr lang="en-US" sz="8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Faculty 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of Tropical Medicine,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Mahidol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University, Mae Sot, Thailand</a:t>
            </a:r>
          </a:p>
          <a:p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8 Centre for Tropical Medicine and Global Health, University of Oxford, Oxford, UK</a:t>
            </a:r>
          </a:p>
          <a:p>
            <a:r>
              <a:rPr lang="en-US" sz="8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9 </a:t>
            </a:r>
            <a:r>
              <a:rPr lang="en-GB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KEMRI/</a:t>
            </a:r>
            <a:r>
              <a:rPr lang="en-GB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Wellcome</a:t>
            </a:r>
            <a:r>
              <a:rPr lang="en-GB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Trust Research Programme, </a:t>
            </a:r>
            <a:r>
              <a:rPr lang="en-GB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Kilifi</a:t>
            </a:r>
            <a:r>
              <a:rPr lang="en-GB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</a:t>
            </a:r>
            <a:r>
              <a:rPr lang="en-GB" sz="8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Kenya</a:t>
            </a:r>
            <a:endParaRPr lang="en-US" sz="800" dirty="0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FoundrySterling-Book"/>
            </a:endParaRPr>
          </a:p>
          <a:p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10 SAMRC Development Pathway for Health Research Unit, </a:t>
            </a:r>
            <a:r>
              <a:rPr lang="en-US" sz="8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Department 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of </a:t>
            </a:r>
            <a:endParaRPr lang="en-US" sz="800" dirty="0" smtClean="0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FoundrySterling-Book"/>
            </a:endParaRPr>
          </a:p>
          <a:p>
            <a:r>
              <a:rPr lang="en-US" sz="800" dirty="0" err="1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Paediatrics</a:t>
            </a:r>
            <a:r>
              <a:rPr lang="en-US" sz="8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and Child Health, University of Witwatersrand, Johannesburg, South Africa</a:t>
            </a:r>
          </a:p>
          <a:p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11 Department of Nutrition and Public Health Interventions Research, </a:t>
            </a:r>
            <a:endParaRPr lang="en-US" sz="800" dirty="0" smtClean="0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FoundrySterling-Book"/>
            </a:endParaRPr>
          </a:p>
          <a:p>
            <a:r>
              <a:rPr lang="en-US" sz="800" dirty="0" smtClean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London 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School of Hygiene and Tropical Medicine, London</a:t>
            </a:r>
          </a:p>
          <a:p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12 Division of </a:t>
            </a:r>
            <a:r>
              <a:rPr lang="en-US" sz="800" dirty="0" err="1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Paediatrics</a:t>
            </a:r>
            <a:r>
              <a:rPr lang="en-US" sz="8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, Pontifical Universidad de Chile, Santiago, Chile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205D0DB-F725-42ED-BCAE-FCB94A33A2D6}"/>
              </a:ext>
            </a:extLst>
          </p:cNvPr>
          <p:cNvSpPr/>
          <p:nvPr/>
        </p:nvSpPr>
        <p:spPr>
          <a:xfrm>
            <a:off x="225425" y="844551"/>
            <a:ext cx="693102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4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International gestational age-specific centiles for umbilical artery Doppler indices: a longitudinal prospective cohort study of the INTERGROWTH-21</a:t>
            </a:r>
            <a:r>
              <a:rPr lang="en-GB" sz="2400" baseline="300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st</a:t>
            </a:r>
            <a:r>
              <a:rPr lang="en-GB" sz="2400" dirty="0">
                <a:ln w="0"/>
                <a:solidFill>
                  <a:schemeClr val="bg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FoundrySterling-Book"/>
              </a:rPr>
              <a:t> Project </a:t>
            </a:r>
            <a:endParaRPr lang="en-US" sz="2400" dirty="0">
              <a:ln w="0"/>
              <a:solidFill>
                <a:schemeClr val="bg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FoundrySterling-Book"/>
            </a:endParaRPr>
          </a:p>
        </p:txBody>
      </p:sp>
    </p:spTree>
    <p:extLst>
      <p:ext uri="{BB962C8B-B14F-4D97-AF65-F5344CB8AC3E}">
        <p14:creationId xmlns:p14="http://schemas.microsoft.com/office/powerpoint/2010/main" val="42259270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7675" y="822614"/>
            <a:ext cx="7743826" cy="49090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>
                <a:solidFill>
                  <a:schemeClr val="tx2"/>
                </a:solidFill>
              </a:rPr>
              <a:t>Methods - population</a:t>
            </a:r>
          </a:p>
          <a:p>
            <a:pPr algn="just"/>
            <a:endParaRPr lang="en-US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Sites</a:t>
            </a:r>
          </a:p>
          <a:p>
            <a:pPr marL="775000" lvl="1" indent="-342900">
              <a:buFont typeface="Arial" panose="020B0604020202020204" pitchFamily="34" charset="0"/>
              <a:buChar char="•"/>
            </a:pPr>
            <a:r>
              <a:rPr lang="en-GB" dirty="0"/>
              <a:t>Pelotas, Brazil </a:t>
            </a:r>
          </a:p>
          <a:p>
            <a:pPr marL="775000" lvl="1" indent="-342900">
              <a:buFont typeface="Arial" panose="020B0604020202020204" pitchFamily="34" charset="0"/>
              <a:buChar char="•"/>
            </a:pPr>
            <a:r>
              <a:rPr lang="en-GB" dirty="0"/>
              <a:t>Oxford, UK </a:t>
            </a:r>
          </a:p>
          <a:p>
            <a:pPr marL="775000" lvl="1" indent="-342900">
              <a:buFont typeface="Arial" panose="020B0604020202020204" pitchFamily="34" charset="0"/>
              <a:buChar char="•"/>
            </a:pPr>
            <a:r>
              <a:rPr lang="en-GB" dirty="0"/>
              <a:t>Parklands suburb of Nairobi, Kenya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Selection criteria at population level: </a:t>
            </a:r>
          </a:p>
          <a:p>
            <a:pPr marL="775000" lvl="1" indent="-342900">
              <a:buFont typeface="Arial" panose="020B0604020202020204" pitchFamily="34" charset="0"/>
              <a:buChar char="•"/>
            </a:pPr>
            <a:r>
              <a:rPr lang="en-GB" dirty="0"/>
              <a:t>altitude &lt;1,600m </a:t>
            </a:r>
          </a:p>
          <a:p>
            <a:pPr marL="775000" lvl="1" indent="-342900">
              <a:buFont typeface="Arial" panose="020B0604020202020204" pitchFamily="34" charset="0"/>
              <a:buChar char="•"/>
            </a:pPr>
            <a:r>
              <a:rPr lang="en-GB" dirty="0"/>
              <a:t>low risk of </a:t>
            </a:r>
            <a:r>
              <a:rPr lang="en-GB" dirty="0" err="1"/>
              <a:t>fetal</a:t>
            </a:r>
            <a:r>
              <a:rPr lang="en-GB" dirty="0"/>
              <a:t> and infant growth and developmental </a:t>
            </a:r>
            <a:r>
              <a:rPr lang="en-GB" dirty="0" smtClean="0"/>
              <a:t>disturbances </a:t>
            </a:r>
            <a:endParaRPr lang="en-GB" dirty="0"/>
          </a:p>
          <a:p>
            <a:pPr marL="775000" lvl="1" indent="-342900">
              <a:buFont typeface="Arial" panose="020B0604020202020204" pitchFamily="34" charset="0"/>
              <a:buChar char="•"/>
            </a:pPr>
            <a:r>
              <a:rPr lang="en-GB" dirty="0"/>
              <a:t>absence or low levels of major, known, non-microbiological </a:t>
            </a:r>
            <a:r>
              <a:rPr lang="en-GB" dirty="0" smtClean="0"/>
              <a:t>contamination</a:t>
            </a:r>
            <a:endParaRPr lang="en-GB" dirty="0"/>
          </a:p>
          <a:p>
            <a:pPr marL="775000" lvl="1" indent="-342900">
              <a:buFont typeface="Arial" panose="020B0604020202020204" pitchFamily="34" charset="0"/>
              <a:buChar char="•"/>
            </a:pPr>
            <a:r>
              <a:rPr lang="en-GB" dirty="0"/>
              <a:t>All “private” or “corporation” hospitals and/or serving middle to upper socioeconomic population were selected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Selection criteria at individual level: </a:t>
            </a:r>
          </a:p>
          <a:p>
            <a:pPr marL="775000" lvl="1" indent="-342900">
              <a:buFont typeface="Arial" panose="020B0604020202020204" pitchFamily="34" charset="0"/>
              <a:buChar char="•"/>
            </a:pPr>
            <a:r>
              <a:rPr lang="en-GB" dirty="0"/>
              <a:t>Women who fulfilled the strict FGLS inclusion criteria of optimal health, nutrition, education, and socioeconomic status, contributed data to the present analysis. </a:t>
            </a:r>
            <a:endParaRPr lang="en-GB" dirty="0" smtClean="0"/>
          </a:p>
        </p:txBody>
      </p:sp>
    </p:spTree>
    <p:extLst>
      <p:ext uri="{BB962C8B-B14F-4D97-AF65-F5344CB8AC3E}">
        <p14:creationId xmlns:p14="http://schemas.microsoft.com/office/powerpoint/2010/main" val="11299003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3">
            <a:lum bright="70000" contrast="-70000"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artisticBlur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1174" y="925368"/>
            <a:ext cx="7614564" cy="4804064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447675" y="822614"/>
            <a:ext cx="7743826" cy="566308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Methods - umbilical artery measurements</a:t>
            </a:r>
            <a:endParaRPr lang="en-GB" altLang="en-US" sz="2400" b="1" dirty="0">
              <a:solidFill>
                <a:schemeClr val="tx2"/>
              </a:solidFill>
            </a:endParaRPr>
          </a:p>
          <a:p>
            <a:pPr algn="just"/>
            <a:endParaRPr lang="en-US" sz="240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 smtClean="0"/>
              <a:t>Free-floating </a:t>
            </a:r>
            <a:r>
              <a:rPr lang="en-US" sz="2000" dirty="0"/>
              <a:t>loop of the umbilical </a:t>
            </a:r>
            <a:r>
              <a:rPr lang="en-US" sz="2000" dirty="0" smtClean="0"/>
              <a:t>cord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 err="1" smtClean="0"/>
              <a:t>Fetal</a:t>
            </a:r>
            <a:r>
              <a:rPr lang="en-GB" sz="2000" dirty="0" smtClean="0"/>
              <a:t> </a:t>
            </a:r>
            <a:r>
              <a:rPr lang="en-US" sz="2000" dirty="0" smtClean="0"/>
              <a:t>quiescence ensured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 smtClean="0"/>
              <a:t>A</a:t>
            </a:r>
            <a:r>
              <a:rPr lang="en-US" sz="2000" dirty="0" smtClean="0"/>
              <a:t>voidance </a:t>
            </a:r>
            <a:r>
              <a:rPr lang="en-US" sz="2000" dirty="0"/>
              <a:t>of venous </a:t>
            </a:r>
            <a:r>
              <a:rPr lang="en-US" sz="2000" dirty="0" smtClean="0"/>
              <a:t>signal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 smtClean="0"/>
              <a:t>Magnification </a:t>
            </a:r>
            <a:r>
              <a:rPr lang="en-US" sz="2000" dirty="0" smtClean="0"/>
              <a:t>(no </a:t>
            </a:r>
            <a:r>
              <a:rPr lang="en-US" sz="2000" dirty="0"/>
              <a:t>less than 50</a:t>
            </a:r>
            <a:r>
              <a:rPr lang="en-US" sz="2000" dirty="0" smtClean="0"/>
              <a:t>%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 smtClean="0"/>
              <a:t>S</a:t>
            </a:r>
            <a:r>
              <a:rPr lang="en-US" sz="2000" dirty="0" smtClean="0"/>
              <a:t>ample </a:t>
            </a:r>
            <a:r>
              <a:rPr lang="en-US" sz="2000" dirty="0"/>
              <a:t>gate within the center of the </a:t>
            </a:r>
            <a:r>
              <a:rPr lang="en-US" sz="2000" dirty="0" smtClean="0"/>
              <a:t>vessel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 smtClean="0"/>
              <a:t>Angle </a:t>
            </a:r>
            <a:r>
              <a:rPr lang="en-US" sz="2000" dirty="0"/>
              <a:t>correction employed (less than 30</a:t>
            </a:r>
            <a:r>
              <a:rPr lang="en-US" sz="2000" dirty="0" smtClean="0"/>
              <a:t>°)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 err="1" smtClean="0"/>
              <a:t>Color</a:t>
            </a:r>
            <a:r>
              <a:rPr lang="en-GB" sz="2000" dirty="0" smtClean="0"/>
              <a:t> </a:t>
            </a:r>
            <a:r>
              <a:rPr lang="en-US" sz="2000" dirty="0" smtClean="0"/>
              <a:t>Doppler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 smtClean="0"/>
              <a:t>Sweep </a:t>
            </a:r>
            <a:r>
              <a:rPr lang="en-US" sz="2000" dirty="0"/>
              <a:t>speed 4-6 consistent waveforms of similar </a:t>
            </a:r>
            <a:r>
              <a:rPr lang="en-US" sz="2000" dirty="0" smtClean="0"/>
              <a:t>signal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 smtClean="0"/>
              <a:t>Velocity </a:t>
            </a:r>
            <a:r>
              <a:rPr lang="en-US" sz="2000" dirty="0"/>
              <a:t>scale of approximately 75% of the peak systolic </a:t>
            </a:r>
            <a:r>
              <a:rPr lang="en-US" sz="2000" dirty="0" smtClean="0"/>
              <a:t>velocity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000" dirty="0"/>
              <a:t>A</a:t>
            </a:r>
            <a:r>
              <a:rPr lang="en-US" sz="2000" dirty="0" smtClean="0"/>
              <a:t>djusting </a:t>
            </a:r>
            <a:r>
              <a:rPr lang="en-US" sz="2000" dirty="0"/>
              <a:t>pulse repetition frequency and color gain </a:t>
            </a:r>
            <a:r>
              <a:rPr lang="en-US" sz="2000" dirty="0" smtClean="0"/>
              <a:t>correc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 smtClean="0"/>
              <a:t>Average</a:t>
            </a:r>
            <a:r>
              <a:rPr lang="en-US" sz="2000" dirty="0" smtClean="0"/>
              <a:t> </a:t>
            </a:r>
            <a:r>
              <a:rPr lang="en-US" sz="2000" dirty="0"/>
              <a:t>of three waveforms used in the </a:t>
            </a:r>
            <a:r>
              <a:rPr lang="en-US" sz="2000" dirty="0" smtClean="0"/>
              <a:t>analysi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/>
              <a:t>24 sonographers, well trained and standardized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/>
              <a:t>Comprehensive prospective and ongoing quality control strategy</a:t>
            </a:r>
          </a:p>
          <a:p>
            <a:pPr marL="775000" lvl="1" indent="-342900">
              <a:buFont typeface="Arial" panose="020B0604020202020204" pitchFamily="34" charset="0"/>
              <a:buChar char="•"/>
            </a:pPr>
            <a:endParaRPr lang="en-GB" sz="160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5704572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7675" y="822614"/>
            <a:ext cx="774382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Method</a:t>
            </a:r>
            <a:endParaRPr lang="en-GB" sz="1600" dirty="0" smtClean="0"/>
          </a:p>
        </p:txBody>
      </p:sp>
      <p:graphicFrame>
        <p:nvGraphicFramePr>
          <p:cNvPr id="6" name="Diagram 5"/>
          <p:cNvGraphicFramePr/>
          <p:nvPr>
            <p:extLst>
              <p:ext uri="{D42A27DB-BD31-4B8C-83A1-F6EECF244321}">
                <p14:modId xmlns:p14="http://schemas.microsoft.com/office/powerpoint/2010/main" val="1438626307"/>
              </p:ext>
            </p:extLst>
          </p:nvPr>
        </p:nvGraphicFramePr>
        <p:xfrm>
          <a:off x="192530" y="822614"/>
          <a:ext cx="8448233" cy="186283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7" name="Rectangle 6"/>
          <p:cNvSpPr/>
          <p:nvPr/>
        </p:nvSpPr>
        <p:spPr bwMode="auto">
          <a:xfrm>
            <a:off x="101721" y="2730734"/>
            <a:ext cx="2078924" cy="29700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b="1" dirty="0" smtClean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Blinded ultrasound </a:t>
            </a:r>
            <a:r>
              <a:rPr lang="en-GB" b="1" dirty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measures: </a:t>
            </a:r>
          </a:p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9-14 weeks</a:t>
            </a:r>
          </a:p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endParaRPr lang="en-GB" dirty="0" smtClean="0">
              <a:solidFill>
                <a:srgbClr val="4F81BD">
                  <a:lumMod val="50000"/>
                </a:srgbClr>
              </a:solidFill>
              <a:latin typeface="Corbel" charset="0"/>
              <a:ea typeface="Corbel" charset="0"/>
              <a:cs typeface="Corbel" charset="0"/>
            </a:endParaRPr>
          </a:p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 smtClean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Then every</a:t>
            </a:r>
          </a:p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 smtClean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 </a:t>
            </a:r>
            <a:r>
              <a:rPr lang="en-GB" dirty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5 ± 1 </a:t>
            </a:r>
            <a:r>
              <a:rPr lang="en-GB" dirty="0" smtClean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weeks</a:t>
            </a:r>
          </a:p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endParaRPr lang="en-GB" dirty="0">
              <a:solidFill>
                <a:srgbClr val="4F81BD">
                  <a:lumMod val="50000"/>
                </a:srgbClr>
              </a:solidFill>
              <a:latin typeface="Corbel" charset="0"/>
              <a:ea typeface="Corbel" charset="0"/>
              <a:cs typeface="Corbel" charset="0"/>
            </a:endParaRPr>
          </a:p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b="1" dirty="0" smtClean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Doppler from 22 weeks</a:t>
            </a:r>
          </a:p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endParaRPr lang="en-GB" b="1" dirty="0">
              <a:solidFill>
                <a:srgbClr val="4F81BD">
                  <a:lumMod val="50000"/>
                </a:srgbClr>
              </a:solidFill>
              <a:latin typeface="Corbel" charset="0"/>
              <a:ea typeface="Corbel" charset="0"/>
              <a:cs typeface="Corbel" charset="0"/>
            </a:endParaRPr>
          </a:p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b="1" dirty="0" smtClean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Identical equipment</a:t>
            </a:r>
            <a:endParaRPr lang="en-US" b="1" dirty="0">
              <a:solidFill>
                <a:srgbClr val="4F81BD">
                  <a:lumMod val="50000"/>
                </a:srgbClr>
              </a:solidFill>
              <a:latin typeface="Corbel" charset="0"/>
              <a:ea typeface="Corbel" charset="0"/>
              <a:cs typeface="Corbel" charset="0"/>
            </a:endParaRPr>
          </a:p>
        </p:txBody>
      </p:sp>
      <p:sp>
        <p:nvSpPr>
          <p:cNvPr id="8" name="Rectangle 7"/>
          <p:cNvSpPr/>
          <p:nvPr/>
        </p:nvSpPr>
        <p:spPr bwMode="auto">
          <a:xfrm>
            <a:off x="2314397" y="2730734"/>
            <a:ext cx="6170614" cy="120014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>
            <a:spAutoFit/>
          </a:bodyPr>
          <a:lstStyle/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b="1" dirty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Anthropometric measurements:</a:t>
            </a:r>
          </a:p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Length/height</a:t>
            </a:r>
          </a:p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Weight</a:t>
            </a:r>
          </a:p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dirty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Head circumference</a:t>
            </a:r>
            <a:endParaRPr lang="en-US" dirty="0">
              <a:solidFill>
                <a:srgbClr val="4F81BD">
                  <a:lumMod val="50000"/>
                </a:srgbClr>
              </a:solidFill>
              <a:latin typeface="Corbel" charset="0"/>
              <a:ea typeface="Corbel" charset="0"/>
              <a:cs typeface="Corbel" charset="0"/>
            </a:endParaRPr>
          </a:p>
        </p:txBody>
      </p:sp>
      <p:sp>
        <p:nvSpPr>
          <p:cNvPr id="9" name="Rectangle 8"/>
          <p:cNvSpPr/>
          <p:nvPr/>
        </p:nvSpPr>
        <p:spPr bwMode="auto">
          <a:xfrm>
            <a:off x="6447836" y="4070348"/>
            <a:ext cx="2037175" cy="52322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 defTabSz="457039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400" b="1" dirty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Neurodevelopment </a:t>
            </a:r>
            <a:r>
              <a:rPr lang="en-GB" sz="1400" b="1" dirty="0" smtClean="0">
                <a:solidFill>
                  <a:srgbClr val="4F81BD">
                    <a:lumMod val="50000"/>
                  </a:srgbClr>
                </a:solidFill>
                <a:latin typeface="Corbel" charset="0"/>
                <a:ea typeface="Corbel" charset="0"/>
                <a:cs typeface="Corbel" charset="0"/>
              </a:rPr>
              <a:t>assessment</a:t>
            </a:r>
            <a:endParaRPr lang="en-GB" sz="1400" b="1" dirty="0">
              <a:solidFill>
                <a:srgbClr val="4F81BD">
                  <a:lumMod val="50000"/>
                </a:srgbClr>
              </a:solidFill>
              <a:latin typeface="Corbel" charset="0"/>
              <a:ea typeface="Corbel" charset="0"/>
              <a:cs typeface="Corbe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74691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4921" y="828676"/>
            <a:ext cx="7949334" cy="40318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>
                <a:solidFill>
                  <a:schemeClr val="tx2"/>
                </a:solidFill>
              </a:rPr>
              <a:t>Results</a:t>
            </a:r>
          </a:p>
          <a:p>
            <a:pPr algn="just"/>
            <a:endParaRPr lang="en-US" sz="2400" dirty="0"/>
          </a:p>
          <a:p>
            <a:pPr marL="342900" indent="-342900" algn="just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US" sz="2400" dirty="0" smtClean="0"/>
              <a:t>431 women</a:t>
            </a:r>
          </a:p>
          <a:p>
            <a:pPr marL="342900" indent="-342900" algn="just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2400" dirty="0" smtClean="0"/>
              <a:t>1243 Doppler scans</a:t>
            </a:r>
            <a:endParaRPr lang="en-US" sz="2400" dirty="0"/>
          </a:p>
          <a:p>
            <a:pPr marL="342900" indent="-342900" algn="just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US" sz="2400" dirty="0"/>
              <a:t>75% of women had ≥3 measures</a:t>
            </a:r>
          </a:p>
          <a:p>
            <a:pPr marL="342900" indent="-342900" algn="just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US" sz="2400" dirty="0"/>
              <a:t>Between </a:t>
            </a:r>
            <a:r>
              <a:rPr lang="en-US" sz="2400" dirty="0" smtClean="0"/>
              <a:t>20 and 119 </a:t>
            </a:r>
            <a:r>
              <a:rPr lang="en-US" sz="2400" dirty="0"/>
              <a:t>individual observations per week</a:t>
            </a:r>
          </a:p>
          <a:p>
            <a:pPr marL="342900" indent="-342900" algn="just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US" sz="2400" dirty="0"/>
              <a:t>Low rates of adverse events confirmed the low-risk status of the population: preterm birth </a:t>
            </a:r>
            <a:r>
              <a:rPr lang="en-US" sz="2400" dirty="0" smtClean="0"/>
              <a:t>(5</a:t>
            </a:r>
            <a:r>
              <a:rPr lang="en-US" sz="2400" dirty="0"/>
              <a:t>%), pre-eclampsia </a:t>
            </a:r>
            <a:r>
              <a:rPr lang="en-US" sz="2400" dirty="0" smtClean="0"/>
              <a:t>(&lt;1%), </a:t>
            </a:r>
            <a:r>
              <a:rPr lang="en-US" sz="2400" dirty="0"/>
              <a:t>neonatal mortality (</a:t>
            </a:r>
            <a:r>
              <a:rPr lang="en-US" sz="2400" dirty="0" smtClean="0"/>
              <a:t>0%), and term low birth weight (3%)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419345588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297420" y="163658"/>
            <a:ext cx="548207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Results</a:t>
            </a:r>
            <a:endParaRPr lang="en-GB" altLang="en-US" sz="2400" b="1" dirty="0">
              <a:solidFill>
                <a:schemeClr val="tx2"/>
              </a:solidFill>
            </a:endParaRPr>
          </a:p>
        </p:txBody>
      </p:sp>
      <p:pic>
        <p:nvPicPr>
          <p:cNvPr id="6" name="Content Placeholder 22">
            <a:extLst>
              <a:ext uri="{FF2B5EF4-FFF2-40B4-BE49-F238E27FC236}">
                <a16:creationId xmlns:a16="http://schemas.microsoft.com/office/drawing/2014/main" id="{802993B7-2A45-432C-A6D9-4AA98CB080A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7617" y="961043"/>
            <a:ext cx="6496050" cy="487203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41577692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11">
            <a:extLst>
              <a:ext uri="{FF2B5EF4-FFF2-40B4-BE49-F238E27FC236}">
                <a16:creationId xmlns:a16="http://schemas.microsoft.com/office/drawing/2014/main" id="{0A70F442-E994-4CB1-B26F-9C888BF2568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7617" y="961043"/>
            <a:ext cx="6496050" cy="487203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9" name="Rectangle 8"/>
          <p:cNvSpPr/>
          <p:nvPr/>
        </p:nvSpPr>
        <p:spPr>
          <a:xfrm>
            <a:off x="1297420" y="163658"/>
            <a:ext cx="548207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Results</a:t>
            </a:r>
            <a:endParaRPr lang="en-GB" altLang="en-US" sz="2400" b="1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357610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98A1BAAF-5708-4F6E-BB88-75913ED9B896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83" b="22753"/>
          <a:stretch/>
        </p:blipFill>
        <p:spPr bwMode="auto">
          <a:xfrm>
            <a:off x="1352482" y="874202"/>
            <a:ext cx="5935799" cy="4796926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0" name="Rectangle 9"/>
          <p:cNvSpPr/>
          <p:nvPr/>
        </p:nvSpPr>
        <p:spPr>
          <a:xfrm>
            <a:off x="1297420" y="163658"/>
            <a:ext cx="548207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Results</a:t>
            </a:r>
            <a:endParaRPr lang="en-GB" altLang="en-US" sz="2400" b="1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405198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r="6866" b="2715"/>
          <a:stretch/>
        </p:blipFill>
        <p:spPr>
          <a:xfrm>
            <a:off x="2329496" y="1290339"/>
            <a:ext cx="3980183" cy="4494677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8" name="Rectangle 7"/>
          <p:cNvSpPr/>
          <p:nvPr/>
        </p:nvSpPr>
        <p:spPr>
          <a:xfrm>
            <a:off x="447675" y="828676"/>
            <a:ext cx="774382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Results</a:t>
            </a:r>
            <a:endParaRPr lang="en-US" sz="2400" dirty="0"/>
          </a:p>
        </p:txBody>
      </p:sp>
      <p:sp>
        <p:nvSpPr>
          <p:cNvPr id="10" name="Rectangle 9"/>
          <p:cNvSpPr/>
          <p:nvPr/>
        </p:nvSpPr>
        <p:spPr>
          <a:xfrm>
            <a:off x="1751013" y="905619"/>
            <a:ext cx="852646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sz="1400" dirty="0"/>
              <a:t>Umbilical artery </a:t>
            </a:r>
            <a:r>
              <a:rPr lang="en-US" sz="1400" dirty="0" err="1"/>
              <a:t>Pulsatility</a:t>
            </a:r>
            <a:r>
              <a:rPr lang="en-US" sz="1400" dirty="0"/>
              <a:t> Index (</a:t>
            </a:r>
            <a:r>
              <a:rPr lang="en-US" sz="1400" dirty="0" smtClean="0"/>
              <a:t>PI) centile </a:t>
            </a:r>
            <a:r>
              <a:rPr lang="en-US" sz="1400" dirty="0"/>
              <a:t>values according to gestational age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15359740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13930" y="1170421"/>
            <a:ext cx="7743826" cy="35086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Discussion</a:t>
            </a:r>
            <a:endParaRPr lang="en-GB" altLang="en-US" sz="2400" b="1" dirty="0">
              <a:solidFill>
                <a:schemeClr val="tx2"/>
              </a:solidFill>
            </a:endParaRPr>
          </a:p>
          <a:p>
            <a:pPr algn="just"/>
            <a:endParaRPr lang="en-US" sz="2400" dirty="0"/>
          </a:p>
          <a:p>
            <a:pPr marL="342900" indent="-342900" algn="just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2400" dirty="0" smtClean="0"/>
              <a:t>We </a:t>
            </a:r>
            <a:r>
              <a:rPr lang="en-GB" sz="2400" dirty="0"/>
              <a:t>were able to overcome limitations of previous studies</a:t>
            </a:r>
            <a:endParaRPr lang="en-GB" sz="2400" dirty="0" smtClean="0"/>
          </a:p>
          <a:p>
            <a:pPr marL="342900" indent="-342900" algn="just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2400" dirty="0" smtClean="0"/>
              <a:t>This will help to standardize </a:t>
            </a:r>
            <a:r>
              <a:rPr lang="en-GB" sz="2400" dirty="0"/>
              <a:t>clinical </a:t>
            </a:r>
            <a:r>
              <a:rPr lang="en-GB" sz="2400" dirty="0" smtClean="0"/>
              <a:t>practice</a:t>
            </a:r>
          </a:p>
          <a:p>
            <a:pPr marL="342900" indent="-342900" algn="just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2400" dirty="0" smtClean="0"/>
              <a:t>Helpful for </a:t>
            </a:r>
            <a:r>
              <a:rPr lang="en-GB" sz="2400" dirty="0"/>
              <a:t>the assessment of fetal wellbeing and placental function in high-risk </a:t>
            </a:r>
            <a:r>
              <a:rPr lang="en-GB" sz="2400" dirty="0" smtClean="0"/>
              <a:t>pregnancies</a:t>
            </a:r>
          </a:p>
          <a:p>
            <a:pPr marL="342900" indent="-342900" algn="just">
              <a:spcAft>
                <a:spcPts val="1200"/>
              </a:spcAft>
              <a:buFont typeface="Arial" panose="020B0604020202020204" pitchFamily="34" charset="0"/>
              <a:buChar char="•"/>
            </a:pPr>
            <a:r>
              <a:rPr lang="en-GB" sz="2400" dirty="0" smtClean="0"/>
              <a:t>We provide standard definitions for studies reporting of umbilical artery Doppler measurements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6865982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7675" y="822614"/>
            <a:ext cx="7743826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Background</a:t>
            </a:r>
            <a:endParaRPr lang="en-GB" altLang="en-US" sz="2400" b="1" dirty="0">
              <a:solidFill>
                <a:schemeClr val="tx2"/>
              </a:solidFill>
            </a:endParaRPr>
          </a:p>
          <a:p>
            <a:pPr algn="just"/>
            <a:endParaRPr lang="en-US" sz="2400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GB" sz="2000" dirty="0" smtClean="0"/>
              <a:t>Umbilical </a:t>
            </a:r>
            <a:r>
              <a:rPr lang="en-GB" sz="2000" dirty="0"/>
              <a:t>artery Doppler reflects impedance to blood flow in the </a:t>
            </a:r>
            <a:r>
              <a:rPr lang="en-GB" sz="2000" dirty="0" err="1"/>
              <a:t>fetal</a:t>
            </a:r>
            <a:r>
              <a:rPr lang="en-GB" sz="2000" dirty="0"/>
              <a:t> compartment of the placental vascular tree</a:t>
            </a:r>
            <a:r>
              <a:rPr lang="en-GB" sz="2000" dirty="0" smtClean="0"/>
              <a:t>.</a:t>
            </a:r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GB" sz="2000" dirty="0" smtClean="0"/>
              <a:t>The </a:t>
            </a:r>
            <a:r>
              <a:rPr lang="en-GB" sz="2000" dirty="0"/>
              <a:t>clinical value of measuring the umbilical artery Doppler is now well-established in high-risk pregnancy and reduces perinatal death.</a:t>
            </a:r>
          </a:p>
        </p:txBody>
      </p:sp>
      <p:sp>
        <p:nvSpPr>
          <p:cNvPr id="4" name="Rectangle 3"/>
          <p:cNvSpPr/>
          <p:nvPr/>
        </p:nvSpPr>
        <p:spPr>
          <a:xfrm>
            <a:off x="1338625" y="5521366"/>
            <a:ext cx="607882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/>
              <a:t>Fetal and umbilical Doppler ultrasound in high‐risk pregnancies. Cochrane Database </a:t>
            </a:r>
            <a:r>
              <a:rPr lang="en-US" sz="1100" dirty="0" err="1"/>
              <a:t>Syst</a:t>
            </a:r>
            <a:r>
              <a:rPr lang="en-US" sz="1100" dirty="0"/>
              <a:t> Rev. 2017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r="2040"/>
          <a:stretch/>
        </p:blipFill>
        <p:spPr>
          <a:xfrm>
            <a:off x="1246307" y="3053444"/>
            <a:ext cx="6148149" cy="22991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04022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7675" y="822614"/>
            <a:ext cx="7743826" cy="11387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Background</a:t>
            </a:r>
            <a:endParaRPr lang="en-GB" altLang="en-US" sz="2400" b="1" dirty="0">
              <a:solidFill>
                <a:schemeClr val="tx2"/>
              </a:solidFill>
            </a:endParaRPr>
          </a:p>
          <a:p>
            <a:pPr algn="just"/>
            <a:endParaRPr lang="en-US" sz="2400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GB" sz="2000" dirty="0" smtClean="0"/>
              <a:t>Management decisions are made </a:t>
            </a:r>
            <a:r>
              <a:rPr lang="en-GB" sz="2000" dirty="0"/>
              <a:t>based on umbilical artery </a:t>
            </a:r>
            <a:r>
              <a:rPr lang="en-GB" sz="2000" dirty="0" smtClean="0"/>
              <a:t>Doppler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</a:extLst>
          </a:blip>
          <a:srcRect t="-1" r="754" b="1702"/>
          <a:stretch/>
        </p:blipFill>
        <p:spPr>
          <a:xfrm>
            <a:off x="2418895" y="3105701"/>
            <a:ext cx="1669996" cy="1748276"/>
          </a:xfrm>
          <a:prstGeom prst="rect">
            <a:avLst/>
          </a:prstGeom>
          <a:ln>
            <a:solidFill>
              <a:srgbClr val="FFFF00"/>
            </a:solidFill>
          </a:ln>
        </p:spPr>
      </p:pic>
      <p:sp>
        <p:nvSpPr>
          <p:cNvPr id="6" name="Rectangle 5"/>
          <p:cNvSpPr/>
          <p:nvPr/>
        </p:nvSpPr>
        <p:spPr>
          <a:xfrm>
            <a:off x="447675" y="2507030"/>
            <a:ext cx="798004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800" dirty="0" smtClean="0"/>
              <a:t>Normal			High </a:t>
            </a:r>
            <a:r>
              <a:rPr lang="en-GB" sz="1800" dirty="0"/>
              <a:t>impedance			Absent EDF		</a:t>
            </a:r>
            <a:r>
              <a:rPr lang="en-GB" sz="1800" dirty="0" smtClean="0"/>
              <a:t>	Reversed EDF</a:t>
            </a:r>
            <a:endParaRPr lang="en-GB" sz="1800" dirty="0"/>
          </a:p>
        </p:txBody>
      </p:sp>
      <p:graphicFrame>
        <p:nvGraphicFramePr>
          <p:cNvPr id="7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410336"/>
              </p:ext>
            </p:extLst>
          </p:nvPr>
        </p:nvGraphicFramePr>
        <p:xfrm>
          <a:off x="237091" y="3100483"/>
          <a:ext cx="1669996" cy="17534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0" name="Bitmap Image" r:id="rId6" imgW="2143091" imgH="1400000" progId="Paint.Picture">
                  <p:embed/>
                </p:oleObj>
              </mc:Choice>
              <mc:Fallback>
                <p:oleObj name="Bitmap Image" r:id="rId6" imgW="2143091" imgH="1400000" progId="Paint.Picture">
                  <p:embed/>
                  <p:pic>
                    <p:nvPicPr>
                      <p:cNvPr id="6" name="Object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lum bright="-18000" contrast="24000"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7091" y="3100483"/>
                        <a:ext cx="1669996" cy="1753494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rgbClr val="FFFF00"/>
                        </a:solidFill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0307665"/>
              </p:ext>
            </p:extLst>
          </p:nvPr>
        </p:nvGraphicFramePr>
        <p:xfrm>
          <a:off x="6770114" y="3105701"/>
          <a:ext cx="1657606" cy="17482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1" name="Bitmap Image" r:id="rId8" imgW="2171990" imgH="1266685" progId="Paint.Picture">
                  <p:embed/>
                </p:oleObj>
              </mc:Choice>
              <mc:Fallback>
                <p:oleObj name="Bitmap Image" r:id="rId8" imgW="2171990" imgH="1266685" progId="Paint.Picture">
                  <p:embed/>
                  <p:pic>
                    <p:nvPicPr>
                      <p:cNvPr id="8" name="Object 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70114" y="3105701"/>
                        <a:ext cx="1657606" cy="1748276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rgbClr val="FFFF00"/>
                        </a:solidFill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3056437"/>
              </p:ext>
            </p:extLst>
          </p:nvPr>
        </p:nvGraphicFramePr>
        <p:xfrm>
          <a:off x="4600699" y="3105701"/>
          <a:ext cx="1657606" cy="17482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" name="Bitmap Image" r:id="rId10" imgW="1971950" imgH="1200318" progId="Paint.Picture">
                  <p:embed/>
                </p:oleObj>
              </mc:Choice>
              <mc:Fallback>
                <p:oleObj name="Bitmap Image" r:id="rId10" imgW="1971950" imgH="1200318" progId="Paint.Picture">
                  <p:embed/>
                  <p:pic>
                    <p:nvPicPr>
                      <p:cNvPr id="9" name="Object 1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lum bright="42000" contrast="60000"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00699" y="3105701"/>
                        <a:ext cx="1657606" cy="1748276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rgbClr val="FFFF00"/>
                        </a:solidFill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197874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3686" y="1958765"/>
            <a:ext cx="8020050" cy="252412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28073" y="4572577"/>
            <a:ext cx="733127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altLang="en-US" sz="2400" b="1" dirty="0" smtClean="0">
                <a:solidFill>
                  <a:schemeClr val="tx2"/>
                </a:solidFill>
              </a:rPr>
              <a:t>A clinical example: </a:t>
            </a:r>
          </a:p>
          <a:p>
            <a:pPr algn="ctr"/>
            <a:r>
              <a:rPr lang="en-GB" altLang="en-US" sz="2400" b="1" dirty="0" smtClean="0">
                <a:solidFill>
                  <a:schemeClr val="tx2"/>
                </a:solidFill>
              </a:rPr>
              <a:t>PI is 1.24 at 36+0 weeks. </a:t>
            </a:r>
          </a:p>
          <a:p>
            <a:pPr algn="ctr"/>
            <a:r>
              <a:rPr lang="en-GB" altLang="en-US" sz="2400" b="1" dirty="0" smtClean="0">
                <a:solidFill>
                  <a:schemeClr val="tx2"/>
                </a:solidFill>
              </a:rPr>
              <a:t>How is does this compare to the normal range?</a:t>
            </a:r>
            <a:endParaRPr lang="en-GB" altLang="en-US" sz="2400" b="1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450878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8272" y="900608"/>
            <a:ext cx="8224217" cy="46821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39286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lum bright="70000" contrast="-70000"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artisticBlur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08272" y="900608"/>
            <a:ext cx="8224217" cy="4682134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1387833" y="2456845"/>
            <a:ext cx="5865093" cy="156966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hilly" dir="t">
              <a:rot lat="0" lon="0" rev="18480000"/>
            </a:lightRig>
          </a:scene3d>
          <a:sp3d prstMaterial="clear">
            <a:bevelT h="63500"/>
          </a:sp3d>
        </p:spPr>
        <p:txBody>
          <a:bodyPr wrap="square">
            <a:spAutoFit/>
          </a:bodyPr>
          <a:lstStyle/>
          <a:p>
            <a:r>
              <a:rPr lang="en-GB" sz="4800" dirty="0"/>
              <a:t>Answer: It depends on which chart you </a:t>
            </a:r>
            <a:r>
              <a:rPr lang="en-GB" sz="4800" dirty="0" smtClean="0"/>
              <a:t>use</a:t>
            </a:r>
            <a:endParaRPr lang="en-GB" sz="4800" dirty="0"/>
          </a:p>
        </p:txBody>
      </p:sp>
    </p:spTree>
    <p:extLst>
      <p:ext uri="{BB962C8B-B14F-4D97-AF65-F5344CB8AC3E}">
        <p14:creationId xmlns:p14="http://schemas.microsoft.com/office/powerpoint/2010/main" val="26011894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7675" y="822614"/>
            <a:ext cx="7743826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Background</a:t>
            </a:r>
            <a:endParaRPr lang="en-GB" altLang="en-US" sz="2400" b="1" dirty="0">
              <a:solidFill>
                <a:schemeClr val="tx2"/>
              </a:solidFill>
            </a:endParaRPr>
          </a:p>
          <a:p>
            <a:pPr algn="just"/>
            <a:endParaRPr lang="en-US" sz="240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 smtClean="0"/>
              <a:t>Most </a:t>
            </a:r>
            <a:r>
              <a:rPr lang="en-GB" sz="2000" dirty="0"/>
              <a:t>of the 30 existing Doppler charts have </a:t>
            </a:r>
            <a:r>
              <a:rPr lang="en-GB" sz="2000" dirty="0" smtClean="0"/>
              <a:t>significant methodological </a:t>
            </a:r>
            <a:r>
              <a:rPr lang="en-GB" sz="2000" dirty="0"/>
              <a:t>limitations</a:t>
            </a:r>
          </a:p>
        </p:txBody>
      </p:sp>
      <p:sp>
        <p:nvSpPr>
          <p:cNvPr id="3" name="Rectangle 2"/>
          <p:cNvSpPr/>
          <p:nvPr/>
        </p:nvSpPr>
        <p:spPr>
          <a:xfrm>
            <a:off x="64652" y="2429165"/>
            <a:ext cx="8515927" cy="29741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5793"/>
          <a:stretch/>
        </p:blipFill>
        <p:spPr bwMode="auto">
          <a:xfrm>
            <a:off x="119161" y="2956019"/>
            <a:ext cx="4060728" cy="2132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405"/>
          <a:stretch/>
        </p:blipFill>
        <p:spPr bwMode="auto">
          <a:xfrm>
            <a:off x="4359226" y="2681300"/>
            <a:ext cx="4060727" cy="26822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sp>
        <p:nvSpPr>
          <p:cNvPr id="8" name="Rectangle 7"/>
          <p:cNvSpPr/>
          <p:nvPr/>
        </p:nvSpPr>
        <p:spPr>
          <a:xfrm>
            <a:off x="0" y="5363570"/>
            <a:ext cx="764371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/>
              <a:t>Reference ranges for Doppler indices of umbilical and fetal middle cerebral arteries and </a:t>
            </a:r>
            <a:r>
              <a:rPr lang="en-US" sz="1100" dirty="0" err="1"/>
              <a:t>cerebroplacental</a:t>
            </a:r>
            <a:r>
              <a:rPr lang="en-US" sz="1100" dirty="0"/>
              <a:t> ratio: systematic review. Ultrasound in Obstetrics &amp; Gynecology 2018</a:t>
            </a:r>
          </a:p>
        </p:txBody>
      </p:sp>
    </p:spTree>
    <p:extLst>
      <p:ext uri="{BB962C8B-B14F-4D97-AF65-F5344CB8AC3E}">
        <p14:creationId xmlns:p14="http://schemas.microsoft.com/office/powerpoint/2010/main" val="171943869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7675" y="822614"/>
            <a:ext cx="7743826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Aim</a:t>
            </a:r>
            <a:endParaRPr lang="en-GB" altLang="en-US" sz="2400" b="1" dirty="0">
              <a:solidFill>
                <a:schemeClr val="tx2"/>
              </a:solidFill>
            </a:endParaRPr>
          </a:p>
          <a:p>
            <a:pPr algn="just"/>
            <a:endParaRPr lang="en-US" sz="240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800" dirty="0"/>
              <a:t>To address methodological limitations identified in our systematic review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2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800" dirty="0"/>
              <a:t>To produce international gestational age-specific centiles for umbilical artery Doppler indices for use alongside the INTERGROWTH-21st Standards </a:t>
            </a:r>
          </a:p>
        </p:txBody>
      </p:sp>
    </p:spTree>
    <p:extLst>
      <p:ext uri="{BB962C8B-B14F-4D97-AF65-F5344CB8AC3E}">
        <p14:creationId xmlns:p14="http://schemas.microsoft.com/office/powerpoint/2010/main" val="24769730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7675" y="822614"/>
            <a:ext cx="7743826" cy="44319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2400" b="1" dirty="0" smtClean="0">
                <a:solidFill>
                  <a:schemeClr val="tx2"/>
                </a:solidFill>
              </a:rPr>
              <a:t>Methods - overview</a:t>
            </a:r>
            <a:endParaRPr lang="en-GB" altLang="en-US" sz="2400" b="1" dirty="0">
              <a:solidFill>
                <a:schemeClr val="tx2"/>
              </a:solidFill>
            </a:endParaRPr>
          </a:p>
          <a:p>
            <a:pPr algn="just"/>
            <a:endParaRPr lang="en-US" sz="180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400" dirty="0"/>
              <a:t>Prospective, longitudinal, population based </a:t>
            </a:r>
            <a:r>
              <a:rPr lang="en-GB" sz="2400" dirty="0" smtClean="0"/>
              <a:t>multi-</a:t>
            </a:r>
            <a:r>
              <a:rPr lang="en-GB" sz="2400" dirty="0" err="1" smtClean="0"/>
              <a:t>center</a:t>
            </a:r>
            <a:r>
              <a:rPr lang="en-GB" sz="2400" dirty="0" smtClean="0"/>
              <a:t> </a:t>
            </a:r>
            <a:r>
              <a:rPr lang="en-GB" sz="2400" dirty="0"/>
              <a:t>international </a:t>
            </a:r>
            <a:r>
              <a:rPr lang="en-GB" sz="2400" dirty="0" smtClean="0"/>
              <a:t>study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24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400" dirty="0"/>
              <a:t>Populations and pregnant women matching the recruitment criteria of the INTERGROWTH-21</a:t>
            </a:r>
            <a:r>
              <a:rPr lang="en-GB" sz="2400" baseline="30000" dirty="0"/>
              <a:t>st</a:t>
            </a:r>
            <a:r>
              <a:rPr lang="en-GB" sz="2400" dirty="0"/>
              <a:t> standards </a:t>
            </a:r>
            <a:endParaRPr lang="en-GB" sz="240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24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400" dirty="0"/>
              <a:t>World Health Organization (WHO) prescriptive criteria for optimal health, nutrition, education and socioeconomic status</a:t>
            </a:r>
            <a:r>
              <a:rPr lang="en-GB" sz="2400" dirty="0" smtClean="0"/>
              <a:t>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302903071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pening slid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pening slide alternativ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ext slid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82</TotalTime>
  <Words>833</Words>
  <Application>Microsoft Office PowerPoint</Application>
  <PresentationFormat>Custom</PresentationFormat>
  <Paragraphs>136</Paragraphs>
  <Slides>18</Slides>
  <Notes>18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3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6" baseType="lpstr">
      <vt:lpstr>Arial</vt:lpstr>
      <vt:lpstr>Calibri</vt:lpstr>
      <vt:lpstr>Corbel</vt:lpstr>
      <vt:lpstr>FoundrySterling-Book</vt:lpstr>
      <vt:lpstr>Opening slide</vt:lpstr>
      <vt:lpstr>Opening slide alternative</vt:lpstr>
      <vt:lpstr>Text slide</vt:lpstr>
      <vt:lpstr>Bitmap Imag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of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or Drukker</dc:creator>
  <cp:lastModifiedBy>Lior Drukker</cp:lastModifiedBy>
  <cp:revision>174</cp:revision>
  <dcterms:created xsi:type="dcterms:W3CDTF">2014-03-20T14:30:16Z</dcterms:created>
  <dcterms:modified xsi:type="dcterms:W3CDTF">2019-12-09T16:23:43Z</dcterms:modified>
</cp:coreProperties>
</file>